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19" r:id="rId2"/>
    <p:sldId id="259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0455" autoAdjust="0"/>
  </p:normalViewPr>
  <p:slideViewPr>
    <p:cSldViewPr snapToGrid="0">
      <p:cViewPr varScale="1">
        <p:scale>
          <a:sx n="54" d="100"/>
          <a:sy n="54" d="100"/>
        </p:scale>
        <p:origin x="11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8E8220-2554-47F9-A212-D0573DFF809B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D67708-8145-4B71-B099-3E1D2A915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46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1: Schematic diagram of study</a:t>
            </a:r>
            <a:endParaRPr lang="en-US" sz="1800" b="1" dirty="0">
              <a:solidFill>
                <a:srgbClr val="222222"/>
              </a:solidFill>
              <a:effectLst/>
              <a:highlight>
                <a:srgbClr val="00FF00"/>
              </a:highlight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endParaRPr lang="en-US" sz="1800" dirty="0">
              <a:solidFill>
                <a:srgbClr val="222222"/>
              </a:solidFill>
              <a:effectLst/>
              <a:highlight>
                <a:srgbClr val="00FF00"/>
              </a:highlight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00050" marR="0" indent="-40005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AutoNum type="romanLcParenR"/>
            </a:pP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ce the amplification of </a:t>
            </a:r>
            <a:r>
              <a:rPr lang="en-US" sz="1800" dirty="0" err="1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sseria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nitigistis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tics by loop mediated isothermal amplification (LAMP), generated both specific and </a:t>
            </a:r>
            <a:r>
              <a:rPr lang="en-US" sz="1800" dirty="0" err="1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specfic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mplicons (false positive result)</a:t>
            </a:r>
          </a:p>
          <a:p>
            <a:pPr marL="400050" marR="0" indent="-40005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AutoNum type="romanLcParenR"/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eviate the false positives, the LAMP generated amplicons were subjected to CRISPR/Cas12a cleavage, since CRISPR/Cas12a is guided by sequence specific RNA (called guide RNA that is complimentary to the wanted targets)</a:t>
            </a:r>
          </a:p>
          <a:p>
            <a:pPr marL="400050" marR="0" indent="-40005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AutoNum type="romanLcParenR"/>
            </a:pP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pon the recognition of targeted </a:t>
            </a:r>
            <a:r>
              <a:rPr lang="en-US" sz="1800" dirty="0" err="1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sseria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nitigistis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NA, the collateral activity of CRISPR/Cas12a is initiated that allow Cas12a to cleave both target and nearby off-target probe fragments. Therefore, if relevant fluorescent-quencher-RNA probes present in the reaction, the non-target cleavage of DNA probe -quencher-</a:t>
            </a:r>
            <a:r>
              <a:rPr lang="en-US" sz="1800" dirty="0" err="1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ourescent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be (the 5-base probe </a:t>
            </a:r>
            <a:r>
              <a:rPr lang="en-US" sz="1800" dirty="0"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M-TTATT-</a:t>
            </a:r>
            <a:r>
              <a:rPr lang="en-US" sz="1800" dirty="0" err="1"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BkFQ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at the reviewer commented)</a:t>
            </a:r>
          </a:p>
          <a:p>
            <a:pPr marL="400050" marR="0" indent="-40005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AutoNum type="romanLcParenR"/>
            </a:pP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newly established system was validated in cohorts of 51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FS samples from </a:t>
            </a:r>
            <a:r>
              <a:rPr lang="en-US" sz="1800" i="1" dirty="0">
                <a:effectLst/>
                <a:latin typeface="Arial" panose="020B0604020202020204" pitchFamily="34" charset="0"/>
                <a:ea typeface="Malgun Gothic" panose="020B0503020000020004" pitchFamily="34" charset="-127"/>
              </a:rPr>
              <a:t>N. meningitidis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uspected patients (in parallel with the golden standard real-time PCR</a:t>
            </a:r>
          </a:p>
          <a:p>
            <a:pPr marL="400050" marR="0" indent="-40005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AutoNum type="romanLcParenR"/>
            </a:pP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D67708-8145-4B71-B099-3E1D2A9154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3208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457200" algn="just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2 Trehalose  helps to thermal-stabilize the activity of CRISPR cas12a: </a:t>
            </a:r>
          </a:p>
          <a:p>
            <a:pPr marL="0" marR="0" indent="45720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eft panel: 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 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nitigistis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rived amplicons digested by cas12 from 37 to 55oC in the presence or absence of 320mM Trehalose. The digestion mixture was resolved against 1,5% agarose gel electrophoresis.</a:t>
            </a:r>
          </a:p>
          <a:p>
            <a:pPr marL="0" marR="0" lvl="0" indent="457200" algn="just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dle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nel N. 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nitigistis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rived amplicons digested by cas12 at 55</a:t>
            </a:r>
            <a:r>
              <a:rPr lang="en-US" sz="1800" baseline="300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 with the addition of 0,25 µM fluorescence labelled reporter (FAM-TTATT-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BkFQ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 in the presence or absence of 320mM Trehalose; The activity of 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s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zyme recorded via emitted fluorescence in 510nm in Roche light cycler 480 (at 37</a:t>
            </a:r>
            <a:r>
              <a:rPr lang="en-US" sz="1800" baseline="300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.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indent="45720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ght panel N. 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nitigistis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rived amplicons digested by cas12 at 55</a:t>
            </a:r>
            <a:r>
              <a:rPr lang="en-US" sz="1800" kern="1200" baseline="300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 with the addition of 0,25 µM fluorescence labelled reporter (FAM-TTATT-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BkFQ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 in the presence or absence of 320mM Trehalose; The activity of </a:t>
            </a:r>
            <a:r>
              <a:rPr lang="en-US" sz="18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s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zyme recorded via emitted fluorescence in 510nm in Roche light cycler 480 (at 55</a:t>
            </a:r>
            <a:r>
              <a:rPr lang="en-US" sz="1800" baseline="300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8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.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D67708-8145-4B71-B099-3E1D2A91545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483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3: </a:t>
            </a:r>
            <a:r>
              <a:rPr lang="en-US" sz="1800" b="1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uorescence test chart of 13 positive cases acquired by  the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ombination of LAMP and CRISPR-Cas12a: </a:t>
            </a:r>
            <a:r>
              <a:rPr lang="en-US" sz="1800" b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800" b="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b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00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viation:  S samples,  Ctr (+) positive control, Ctr (-), negative control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D67708-8145-4B71-B099-3E1D2A91545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890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5663D7-C9D8-4E09-AFB3-A0CF85C24A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D44408-65BB-443A-806E-3EC8A31E33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BF8BE6-25CA-42BB-AFD5-E04BE1692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5F6366-E900-4C0B-A6B0-C5BDF90E6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211D8C-6AA5-4DB3-B295-74434D676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262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0B953-E799-4291-930F-8D033C90B3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CE0615-0DD7-4B7A-91FF-7A2A8F0828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1F060-3E01-411A-AA60-4005D3273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932864-4E25-40F4-B989-A2AC16588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585ED4-6901-4C7C-BD32-46F501E6A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57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3FE0A9-244E-4895-A1E3-3ACC277F6D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BE121F-855E-4073-A447-A6E523481C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4731F0-200C-435E-9501-6C58EC7C7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5D5EE2-E0F0-44F9-B0D2-DFCF54C1C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F31D94-78F5-44B1-BE6F-1E6929B4C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664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D1306D-89CB-4914-B452-5390E10BF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F5E60C-DF03-41B7-9428-7A0FA17CF3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4FB42E-FF80-43CC-BBBF-BD019F22B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35FB50-0D3E-43AE-B473-749AA3B31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815629-B8EC-4156-9121-127058D88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651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B43CA-888F-424D-B0A1-CADA748AF7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C555BA-640C-49D5-AC07-977518FA85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9EA647-A9B8-42C1-9896-65B030D5F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C847D-7037-410A-8D0F-7FCFAE2F1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08B27E-3D10-45B8-B316-991F3052E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379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4ECE3-6050-481C-9D81-71598869E9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C51E83-B68B-4B00-9184-D91DBEC82B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42C8D2-227D-4FF6-BDD3-1DF566C9CE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D2360F-95EA-41D8-BF6F-2F93E440A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77D668-65B2-4F16-84EA-5E363DCB9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4F08C2-291A-40D6-AC29-2BB188311E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617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8E41F-7533-459F-BD45-B747179EAD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C10464-590F-42BD-B35B-81B5DF516B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A41EC0-EC3A-4FE1-AFC9-23B13CD751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31FB20-A759-4AA5-839C-F377A895AA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DDB606-9FEA-4918-9235-8751DD913D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F67EBC6-C810-4969-AEBE-E403312AF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9FA82E-D976-4E89-85D8-B253412A5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1072E6-FB44-4003-98E2-3442F1F40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095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FE3F4-7DAD-4AFD-8082-E9CEAE3F81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1404A4-C67E-4587-9D5C-764AC0B98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699EEE-50EF-4F9B-A6AD-CA84B6C0E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D3DB33-33F3-415F-9097-74FA8028D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93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F04951-B1EE-4C2F-AEE6-29B1E19E2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3D65D2-099E-4B1D-9A1D-81A65863E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168D4C-D2A9-42FF-8EF1-7AA8EE82C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618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AF3FB4-2C16-4516-BFCF-40328D549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95FF3A-3FF1-4EC9-BBCE-9EDACAC816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3F5930-7ACE-45FB-B29C-CE2AB5AB21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36F4AD-BF5D-4077-84AF-CA6723D07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576AB3-86DC-4595-AEB9-9638EA8D3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72A912-AABF-4F28-A0DF-10AE73D2A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769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16CF8D-687C-4829-BF24-AB0EDD168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CD5734-10CA-4279-97D9-AA8CB93CDB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E89EC1-E5CD-4F06-9691-C9CFA8F807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0B7110-F624-4477-978A-8142CAFEA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8235EE-4FF7-42E5-9FC8-EE96DB375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4EBE5D-E135-46A0-AC46-B8B681C2C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05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C95090-0FD0-4AC7-B1D4-27CD2013F5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B653D5-E24F-4FE0-A4E2-EA8C2C81E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8A68DF-36CF-4F57-9A5F-CC1B4C4B48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BDDCA-E6A1-4985-8E69-865E6219FA3D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CF9E1F-EE2D-4FC4-A56F-21780E02DC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D084E7-9026-4275-A300-06C56D4288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2CC33-BFB0-4620-A5D3-F202C3C37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322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m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tm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44" name="Picture 11">
            <a:extLst>
              <a:ext uri="{FF2B5EF4-FFF2-40B4-BE49-F238E27FC236}">
                <a16:creationId xmlns:a16="http://schemas.microsoft.com/office/drawing/2014/main" id="{9BC49796-3808-4CD8-BF2C-19A276E7DB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286" y="2659801"/>
            <a:ext cx="1751012" cy="2646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45" name="Picture 26">
            <a:extLst>
              <a:ext uri="{FF2B5EF4-FFF2-40B4-BE49-F238E27FC236}">
                <a16:creationId xmlns:a16="http://schemas.microsoft.com/office/drawing/2014/main" id="{493909AD-004E-4462-A389-A298FF787B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76796" y="1586705"/>
            <a:ext cx="3566591" cy="21303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46" name="Picture 34">
            <a:extLst>
              <a:ext uri="{FF2B5EF4-FFF2-40B4-BE49-F238E27FC236}">
                <a16:creationId xmlns:a16="http://schemas.microsoft.com/office/drawing/2014/main" id="{2D345E05-0089-4D8C-89B6-5587A9046F6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1" t="5833" r="7935" b="8960"/>
          <a:stretch/>
        </p:blipFill>
        <p:spPr bwMode="auto">
          <a:xfrm>
            <a:off x="3810848" y="1630338"/>
            <a:ext cx="3957123" cy="28273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C1841279-DC20-4E1F-8238-6516CD6592FD}"/>
              </a:ext>
            </a:extLst>
          </p:cNvPr>
          <p:cNvCxnSpPr>
            <a:cxnSpLocks/>
          </p:cNvCxnSpPr>
          <p:nvPr/>
        </p:nvCxnSpPr>
        <p:spPr bwMode="auto">
          <a:xfrm>
            <a:off x="7767971" y="2651863"/>
            <a:ext cx="808038" cy="7938"/>
          </a:xfrm>
          <a:prstGeom prst="straightConnector1">
            <a:avLst/>
          </a:prstGeom>
          <a:ln w="76200">
            <a:solidFill>
              <a:srgbClr val="00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B8B7B093-C072-4D20-8A37-7B10105E3179}"/>
              </a:ext>
            </a:extLst>
          </p:cNvPr>
          <p:cNvCxnSpPr>
            <a:cxnSpLocks/>
            <a:stCxn id="14345" idx="2"/>
            <a:endCxn id="18" idx="0"/>
          </p:cNvCxnSpPr>
          <p:nvPr/>
        </p:nvCxnSpPr>
        <p:spPr>
          <a:xfrm flipH="1">
            <a:off x="10260091" y="3717020"/>
            <a:ext cx="1" cy="1240727"/>
          </a:xfrm>
          <a:prstGeom prst="straightConnector1">
            <a:avLst/>
          </a:prstGeom>
          <a:ln w="5715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Plus Sign 10">
            <a:extLst>
              <a:ext uri="{FF2B5EF4-FFF2-40B4-BE49-F238E27FC236}">
                <a16:creationId xmlns:a16="http://schemas.microsoft.com/office/drawing/2014/main" id="{B3EEDD5F-ABB1-4A01-9994-15239AE7B2DC}"/>
              </a:ext>
            </a:extLst>
          </p:cNvPr>
          <p:cNvSpPr/>
          <p:nvPr/>
        </p:nvSpPr>
        <p:spPr>
          <a:xfrm>
            <a:off x="3044086" y="2705923"/>
            <a:ext cx="511175" cy="536575"/>
          </a:xfrm>
          <a:prstGeom prst="mathPl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pic>
        <p:nvPicPr>
          <p:cNvPr id="15374" name="Picture 7">
            <a:extLst>
              <a:ext uri="{FF2B5EF4-FFF2-40B4-BE49-F238E27FC236}">
                <a16:creationId xmlns:a16="http://schemas.microsoft.com/office/drawing/2014/main" id="{31A543B3-4D4E-4108-BF83-60D6900DFB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973" y="875483"/>
            <a:ext cx="3189288" cy="1509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3314">
            <a:extLst>
              <a:ext uri="{FF2B5EF4-FFF2-40B4-BE49-F238E27FC236}">
                <a16:creationId xmlns:a16="http://schemas.microsoft.com/office/drawing/2014/main" id="{FAAA8F69-23B7-4BFC-9787-0710F6F7765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65"/>
          <a:stretch>
            <a:fillRect/>
          </a:stretch>
        </p:blipFill>
        <p:spPr bwMode="auto">
          <a:xfrm>
            <a:off x="8625445" y="4957747"/>
            <a:ext cx="3269292" cy="19481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537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537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 nodeType="clickPar">
                      <p:stCondLst>
                        <p:cond delay="indefinite"/>
                      </p:stCondLst>
                      <p:childTnLst>
                        <p:par>
                          <p:cTn id="1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1434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1434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" dur="500" fill="hold"/>
                                        <p:tgtEl>
                                          <p:spTgt spid="1434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1434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 nodeType="clickPar">
                      <p:stCondLst>
                        <p:cond delay="indefinite"/>
                      </p:stCondLst>
                      <p:childTnLst>
                        <p:par>
                          <p:cTn id="2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9" dur="5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0" dur="5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 nodeType="clickPar">
                      <p:stCondLst>
                        <p:cond delay="indefinite"/>
                      </p:stCondLst>
                      <p:childTnLst>
                        <p:par>
                          <p:cTn id="3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3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5" dur="500" fill="hold"/>
                                        <p:tgtEl>
                                          <p:spTgt spid="1434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" dur="500" fill="hold"/>
                                        <p:tgtEl>
                                          <p:spTgt spid="1434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 nodeType="clickPar">
                      <p:stCondLst>
                        <p:cond delay="indefinite"/>
                      </p:stCondLst>
                      <p:childTnLst>
                        <p:par>
                          <p:cTn id="3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1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2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 nodeType="clickPar">
                      <p:stCondLst>
                        <p:cond delay="indefinite"/>
                      </p:stCondLst>
                      <p:childTnLst>
                        <p:par>
                          <p:cTn id="4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7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8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Clipping">
            <a:extLst>
              <a:ext uri="{FF2B5EF4-FFF2-40B4-BE49-F238E27FC236}">
                <a16:creationId xmlns:a16="http://schemas.microsoft.com/office/drawing/2014/main" id="{0989B113-7EA3-4A71-B88F-A4A8236B026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38" t="11615" r="-2687" b="8819"/>
          <a:stretch/>
        </p:blipFill>
        <p:spPr>
          <a:xfrm>
            <a:off x="8016660" y="1721786"/>
            <a:ext cx="4321472" cy="3414428"/>
          </a:xfrm>
          <a:prstGeom prst="rect">
            <a:avLst/>
          </a:prstGeom>
        </p:spPr>
      </p:pic>
      <p:pic>
        <p:nvPicPr>
          <p:cNvPr id="6" name="Content Placeholder 3" descr="Screen Clipping">
            <a:extLst>
              <a:ext uri="{FF2B5EF4-FFF2-40B4-BE49-F238E27FC236}">
                <a16:creationId xmlns:a16="http://schemas.microsoft.com/office/drawing/2014/main" id="{862D1C4D-2386-4816-A1B7-33E353621F8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52"/>
          <a:stretch/>
        </p:blipFill>
        <p:spPr>
          <a:xfrm>
            <a:off x="814190" y="1721786"/>
            <a:ext cx="3081412" cy="3414428"/>
          </a:xfr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4C6A00F-9F8D-4556-B6C4-57D63E773D7F}"/>
              </a:ext>
            </a:extLst>
          </p:cNvPr>
          <p:cNvSpPr txBox="1"/>
          <p:nvPr/>
        </p:nvSpPr>
        <p:spPr>
          <a:xfrm>
            <a:off x="814190" y="5511995"/>
            <a:ext cx="3306880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dirty="0"/>
              <a:t>-    +   -    +    -   +   -   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2BFD4D-EFAF-4081-AF93-F8D1D075D5BF}"/>
              </a:ext>
            </a:extLst>
          </p:cNvPr>
          <p:cNvSpPr txBox="1"/>
          <p:nvPr/>
        </p:nvSpPr>
        <p:spPr>
          <a:xfrm>
            <a:off x="-67516" y="5596422"/>
            <a:ext cx="13469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rehalos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699F9D-4736-4D93-A49B-B4BD60F933C9}"/>
              </a:ext>
            </a:extLst>
          </p:cNvPr>
          <p:cNvSpPr txBox="1"/>
          <p:nvPr/>
        </p:nvSpPr>
        <p:spPr>
          <a:xfrm>
            <a:off x="2534647" y="843800"/>
            <a:ext cx="13857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55 degre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3EE0958-E9E6-4AA6-8963-6BBCFA57BC5B}"/>
              </a:ext>
            </a:extLst>
          </p:cNvPr>
          <p:cNvSpPr txBox="1"/>
          <p:nvPr/>
        </p:nvSpPr>
        <p:spPr>
          <a:xfrm>
            <a:off x="9169045" y="2471393"/>
            <a:ext cx="1174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Trehalos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B544407-D1C1-4213-B514-E1C34BBF43D0}"/>
              </a:ext>
            </a:extLst>
          </p:cNvPr>
          <p:cNvSpPr txBox="1"/>
          <p:nvPr/>
        </p:nvSpPr>
        <p:spPr>
          <a:xfrm>
            <a:off x="10544933" y="3924413"/>
            <a:ext cx="1612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Non Trehalos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FAB63C-82AB-4771-AF43-F5D5E511D668}"/>
              </a:ext>
            </a:extLst>
          </p:cNvPr>
          <p:cNvSpPr txBox="1"/>
          <p:nvPr/>
        </p:nvSpPr>
        <p:spPr>
          <a:xfrm>
            <a:off x="720688" y="843800"/>
            <a:ext cx="13857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37 degre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B620129-DF03-4E71-BC06-722D97B4094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904" r="21000"/>
          <a:stretch/>
        </p:blipFill>
        <p:spPr>
          <a:xfrm>
            <a:off x="4025145" y="1721786"/>
            <a:ext cx="3811042" cy="341442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8BA8F42-09E7-476F-B4D1-C13AA65EA8E7}"/>
              </a:ext>
            </a:extLst>
          </p:cNvPr>
          <p:cNvSpPr txBox="1"/>
          <p:nvPr/>
        </p:nvSpPr>
        <p:spPr>
          <a:xfrm>
            <a:off x="4899767" y="1972441"/>
            <a:ext cx="1174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Trehalos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C2E39E-38EA-473F-BFF8-76FEAB663C9B}"/>
              </a:ext>
            </a:extLst>
          </p:cNvPr>
          <p:cNvSpPr txBox="1"/>
          <p:nvPr/>
        </p:nvSpPr>
        <p:spPr>
          <a:xfrm>
            <a:off x="5386309" y="3425461"/>
            <a:ext cx="1612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Non Trehalos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1960C48-5495-458E-865B-561CA24BEBA3}"/>
              </a:ext>
            </a:extLst>
          </p:cNvPr>
          <p:cNvSpPr txBox="1"/>
          <p:nvPr/>
        </p:nvSpPr>
        <p:spPr>
          <a:xfrm>
            <a:off x="5119402" y="843800"/>
            <a:ext cx="13857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37 degre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05A858F-913D-4C42-AF2D-5694C66E1C9D}"/>
              </a:ext>
            </a:extLst>
          </p:cNvPr>
          <p:cNvSpPr txBox="1"/>
          <p:nvPr/>
        </p:nvSpPr>
        <p:spPr>
          <a:xfrm>
            <a:off x="9756202" y="843800"/>
            <a:ext cx="13857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55 degree</a:t>
            </a:r>
          </a:p>
        </p:txBody>
      </p:sp>
    </p:spTree>
    <p:extLst>
      <p:ext uri="{BB962C8B-B14F-4D97-AF65-F5344CB8AC3E}">
        <p14:creationId xmlns:p14="http://schemas.microsoft.com/office/powerpoint/2010/main" val="17936673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DB852A9-906A-49FB-BED3-8F44BF01DE0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0751" y="861042"/>
            <a:ext cx="3086100" cy="328704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6A31B84-2C0B-498B-B732-B7C9CFF0C5A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8412" y="854022"/>
            <a:ext cx="3068503" cy="328704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2D69114-E0C2-420D-B2B9-9E6AC2CDB58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8476" y="868062"/>
            <a:ext cx="3068503" cy="328002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F99D443-91EF-4C07-AA30-1D2CAC46EF1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8" r="1482" b="1586"/>
          <a:stretch/>
        </p:blipFill>
        <p:spPr>
          <a:xfrm>
            <a:off x="48985" y="861042"/>
            <a:ext cx="2801766" cy="327300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5FD033B-3CA8-4817-9B0E-D9C19E76137E}"/>
              </a:ext>
            </a:extLst>
          </p:cNvPr>
          <p:cNvSpPr txBox="1"/>
          <p:nvPr/>
        </p:nvSpPr>
        <p:spPr>
          <a:xfrm>
            <a:off x="702129" y="1338943"/>
            <a:ext cx="89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+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D291137-3C53-43F2-8754-B8397F6E020C}"/>
              </a:ext>
            </a:extLst>
          </p:cNvPr>
          <p:cNvSpPr txBox="1"/>
          <p:nvPr/>
        </p:nvSpPr>
        <p:spPr>
          <a:xfrm>
            <a:off x="3544062" y="1725385"/>
            <a:ext cx="8980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6</a:t>
            </a:r>
          </a:p>
          <a:p>
            <a:r>
              <a:rPr lang="en-US" sz="1200" dirty="0" err="1"/>
              <a:t>Crl</a:t>
            </a:r>
            <a:r>
              <a:rPr lang="en-US" sz="1200" dirty="0"/>
              <a:t>(+)</a:t>
            </a:r>
          </a:p>
          <a:p>
            <a:endParaRPr lang="en-US" sz="1200" dirty="0"/>
          </a:p>
          <a:p>
            <a:r>
              <a:rPr lang="en-US" sz="1200" dirty="0"/>
              <a:t>s8</a:t>
            </a:r>
          </a:p>
          <a:p>
            <a:r>
              <a:rPr lang="en-US" sz="1200" dirty="0"/>
              <a:t>s7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276A715-90B7-485C-83B4-3A877E2DF9F4}"/>
              </a:ext>
            </a:extLst>
          </p:cNvPr>
          <p:cNvCxnSpPr>
            <a:cxnSpLocks/>
          </p:cNvCxnSpPr>
          <p:nvPr/>
        </p:nvCxnSpPr>
        <p:spPr>
          <a:xfrm flipH="1">
            <a:off x="3445329" y="1877786"/>
            <a:ext cx="18505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006D13CF-4C5F-47C1-938A-0611E856FF9D}"/>
              </a:ext>
            </a:extLst>
          </p:cNvPr>
          <p:cNvCxnSpPr/>
          <p:nvPr/>
        </p:nvCxnSpPr>
        <p:spPr>
          <a:xfrm>
            <a:off x="3970546" y="2035629"/>
            <a:ext cx="35108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E8FF3DA-2CD3-49D4-BD21-B9D2769A312E}"/>
              </a:ext>
            </a:extLst>
          </p:cNvPr>
          <p:cNvCxnSpPr>
            <a:cxnSpLocks/>
          </p:cNvCxnSpPr>
          <p:nvPr/>
        </p:nvCxnSpPr>
        <p:spPr>
          <a:xfrm>
            <a:off x="3795004" y="2427515"/>
            <a:ext cx="9457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C3923EA-6FD1-46DB-85A8-F6F4E6AE624C}"/>
              </a:ext>
            </a:extLst>
          </p:cNvPr>
          <p:cNvCxnSpPr>
            <a:cxnSpLocks/>
          </p:cNvCxnSpPr>
          <p:nvPr/>
        </p:nvCxnSpPr>
        <p:spPr>
          <a:xfrm>
            <a:off x="3795003" y="2623458"/>
            <a:ext cx="5157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CDDCFFF-9AD8-4953-9F09-B6C7DB3469C6}"/>
              </a:ext>
            </a:extLst>
          </p:cNvPr>
          <p:cNvSpPr txBox="1"/>
          <p:nvPr/>
        </p:nvSpPr>
        <p:spPr>
          <a:xfrm>
            <a:off x="9399796" y="1477442"/>
            <a:ext cx="898072" cy="1448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/>
              <a:t>s18</a:t>
            </a:r>
          </a:p>
          <a:p>
            <a:pPr>
              <a:lnSpc>
                <a:spcPct val="150000"/>
              </a:lnSpc>
            </a:pPr>
            <a:r>
              <a:rPr lang="en-US" sz="1200" dirty="0"/>
              <a:t>s16</a:t>
            </a:r>
          </a:p>
          <a:p>
            <a:pPr>
              <a:lnSpc>
                <a:spcPct val="150000"/>
              </a:lnSpc>
            </a:pPr>
            <a:r>
              <a:rPr lang="en-US" sz="1200" dirty="0" err="1"/>
              <a:t>crl</a:t>
            </a:r>
            <a:r>
              <a:rPr lang="en-US" sz="1200" dirty="0"/>
              <a:t>(+)</a:t>
            </a:r>
          </a:p>
          <a:p>
            <a:pPr>
              <a:lnSpc>
                <a:spcPct val="150000"/>
              </a:lnSpc>
            </a:pPr>
            <a:endParaRPr lang="en-US" sz="1200" dirty="0"/>
          </a:p>
          <a:p>
            <a:pPr>
              <a:lnSpc>
                <a:spcPct val="150000"/>
              </a:lnSpc>
            </a:pPr>
            <a:r>
              <a:rPr lang="en-US" sz="1200" dirty="0"/>
              <a:t>              s19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7CDFA13-FFF0-41B1-9178-1129D34DCDF0}"/>
              </a:ext>
            </a:extLst>
          </p:cNvPr>
          <p:cNvCxnSpPr/>
          <p:nvPr/>
        </p:nvCxnSpPr>
        <p:spPr>
          <a:xfrm>
            <a:off x="9780814" y="1665514"/>
            <a:ext cx="2667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17EEB61-B960-4026-9016-F8603ED3F995}"/>
              </a:ext>
            </a:extLst>
          </p:cNvPr>
          <p:cNvCxnSpPr>
            <a:cxnSpLocks/>
          </p:cNvCxnSpPr>
          <p:nvPr/>
        </p:nvCxnSpPr>
        <p:spPr>
          <a:xfrm>
            <a:off x="9778092" y="1981199"/>
            <a:ext cx="4599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C671D8F-625D-460E-9669-0F594E464D26}"/>
              </a:ext>
            </a:extLst>
          </p:cNvPr>
          <p:cNvCxnSpPr>
            <a:cxnSpLocks/>
          </p:cNvCxnSpPr>
          <p:nvPr/>
        </p:nvCxnSpPr>
        <p:spPr>
          <a:xfrm>
            <a:off x="9817553" y="2233217"/>
            <a:ext cx="3007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63CE0B6F-0222-4B86-BA53-6CBCC57ECB95}"/>
              </a:ext>
            </a:extLst>
          </p:cNvPr>
          <p:cNvCxnSpPr>
            <a:cxnSpLocks/>
          </p:cNvCxnSpPr>
          <p:nvPr/>
        </p:nvCxnSpPr>
        <p:spPr>
          <a:xfrm>
            <a:off x="10297868" y="2804717"/>
            <a:ext cx="1333518" cy="1214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E045347F-F85D-418C-890F-73E0B904173E}"/>
              </a:ext>
            </a:extLst>
          </p:cNvPr>
          <p:cNvSpPr txBox="1"/>
          <p:nvPr/>
        </p:nvSpPr>
        <p:spPr>
          <a:xfrm>
            <a:off x="9622972" y="3646714"/>
            <a:ext cx="2193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(-) human; s14; s15; s17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2D3A7BA-D7CC-4553-9C03-24F03EAB8B12}"/>
              </a:ext>
            </a:extLst>
          </p:cNvPr>
          <p:cNvSpPr txBox="1"/>
          <p:nvPr/>
        </p:nvSpPr>
        <p:spPr>
          <a:xfrm>
            <a:off x="772885" y="3646714"/>
            <a:ext cx="1768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s1; s2; s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8CBA7D2-FB38-4C64-893C-C0CBDFD99F1F}"/>
              </a:ext>
            </a:extLst>
          </p:cNvPr>
          <p:cNvSpPr txBox="1"/>
          <p:nvPr/>
        </p:nvSpPr>
        <p:spPr>
          <a:xfrm>
            <a:off x="6245770" y="1665514"/>
            <a:ext cx="8980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13</a:t>
            </a:r>
          </a:p>
          <a:p>
            <a:r>
              <a:rPr lang="en-US" sz="1200" dirty="0"/>
              <a:t>s10</a:t>
            </a:r>
          </a:p>
          <a:p>
            <a:r>
              <a:rPr lang="en-US" sz="1200" dirty="0" err="1"/>
              <a:t>Crl</a:t>
            </a:r>
            <a:r>
              <a:rPr lang="en-US" sz="1200" dirty="0"/>
              <a:t>(+)</a:t>
            </a:r>
          </a:p>
          <a:p>
            <a:endParaRPr lang="en-US" sz="1200" dirty="0"/>
          </a:p>
          <a:p>
            <a:r>
              <a:rPr lang="en-US" sz="1200" dirty="0"/>
              <a:t>              s12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6F13415A-8BFE-4B39-B8F3-AD9DDAF7A1E7}"/>
              </a:ext>
            </a:extLst>
          </p:cNvPr>
          <p:cNvCxnSpPr/>
          <p:nvPr/>
        </p:nvCxnSpPr>
        <p:spPr>
          <a:xfrm>
            <a:off x="6630162" y="1801586"/>
            <a:ext cx="17184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9928B3D6-310D-4A05-8482-C99DEFD2E5B6}"/>
              </a:ext>
            </a:extLst>
          </p:cNvPr>
          <p:cNvCxnSpPr>
            <a:cxnSpLocks/>
          </p:cNvCxnSpPr>
          <p:nvPr/>
        </p:nvCxnSpPr>
        <p:spPr>
          <a:xfrm>
            <a:off x="6630162" y="1997528"/>
            <a:ext cx="3584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DE596E25-1396-4169-A36F-8F1A7C8011DB}"/>
              </a:ext>
            </a:extLst>
          </p:cNvPr>
          <p:cNvCxnSpPr>
            <a:cxnSpLocks/>
          </p:cNvCxnSpPr>
          <p:nvPr/>
        </p:nvCxnSpPr>
        <p:spPr>
          <a:xfrm>
            <a:off x="6701300" y="2196364"/>
            <a:ext cx="22745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2800F9C0-C6AC-4D7C-AEEA-BC69EF4AF23C}"/>
              </a:ext>
            </a:extLst>
          </p:cNvPr>
          <p:cNvCxnSpPr>
            <a:cxnSpLocks/>
          </p:cNvCxnSpPr>
          <p:nvPr/>
        </p:nvCxnSpPr>
        <p:spPr>
          <a:xfrm>
            <a:off x="7143842" y="2531777"/>
            <a:ext cx="12708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F3CBC513-7C03-4ED3-8A78-0BE6BE856440}"/>
              </a:ext>
            </a:extLst>
          </p:cNvPr>
          <p:cNvSpPr txBox="1"/>
          <p:nvPr/>
        </p:nvSpPr>
        <p:spPr>
          <a:xfrm>
            <a:off x="3856255" y="3639121"/>
            <a:ext cx="1768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s4; s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C34161F-D821-4C96-95DE-06FA5133589C}"/>
              </a:ext>
            </a:extLst>
          </p:cNvPr>
          <p:cNvSpPr txBox="1"/>
          <p:nvPr/>
        </p:nvSpPr>
        <p:spPr>
          <a:xfrm>
            <a:off x="6791125" y="3655449"/>
            <a:ext cx="2193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(-) human; s9; s11</a:t>
            </a: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8F58F887-59B9-4BC2-85BE-B3C524F651F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86" y="4154800"/>
            <a:ext cx="4011386" cy="2613297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83246CCE-841E-461B-83AC-637621C6544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0198" y="4141063"/>
            <a:ext cx="4025103" cy="2611092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DDEF4C98-D98A-461F-A0C5-41AC920233D4}"/>
              </a:ext>
            </a:extLst>
          </p:cNvPr>
          <p:cNvSpPr txBox="1"/>
          <p:nvPr/>
        </p:nvSpPr>
        <p:spPr>
          <a:xfrm>
            <a:off x="632148" y="4872726"/>
            <a:ext cx="8980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26</a:t>
            </a:r>
          </a:p>
          <a:p>
            <a:r>
              <a:rPr lang="en-US" sz="1200" dirty="0" err="1"/>
              <a:t>Crl</a:t>
            </a:r>
            <a:r>
              <a:rPr lang="en-US" sz="1200" dirty="0"/>
              <a:t>(+)</a:t>
            </a:r>
          </a:p>
          <a:p>
            <a:endParaRPr lang="en-US" sz="1200" dirty="0"/>
          </a:p>
          <a:p>
            <a:r>
              <a:rPr lang="en-US" sz="1200" dirty="0"/>
              <a:t>s24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BFA12ACF-6A9B-4322-9DF5-2DACF176986E}"/>
              </a:ext>
            </a:extLst>
          </p:cNvPr>
          <p:cNvCxnSpPr/>
          <p:nvPr/>
        </p:nvCxnSpPr>
        <p:spPr>
          <a:xfrm>
            <a:off x="1151165" y="5012871"/>
            <a:ext cx="90351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0513418E-506C-4EA0-A753-ED0ACE719A9B}"/>
              </a:ext>
            </a:extLst>
          </p:cNvPr>
          <p:cNvCxnSpPr/>
          <p:nvPr/>
        </p:nvCxnSpPr>
        <p:spPr>
          <a:xfrm>
            <a:off x="1145723" y="5212219"/>
            <a:ext cx="90351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50175AB1-4142-4338-9AD6-140ADDE83842}"/>
              </a:ext>
            </a:extLst>
          </p:cNvPr>
          <p:cNvCxnSpPr>
            <a:cxnSpLocks/>
          </p:cNvCxnSpPr>
          <p:nvPr/>
        </p:nvCxnSpPr>
        <p:spPr>
          <a:xfrm>
            <a:off x="1145723" y="5589814"/>
            <a:ext cx="19839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66797775-B2E6-48ED-BBAE-2C91408C5984}"/>
              </a:ext>
            </a:extLst>
          </p:cNvPr>
          <p:cNvSpPr txBox="1"/>
          <p:nvPr/>
        </p:nvSpPr>
        <p:spPr>
          <a:xfrm>
            <a:off x="5822151" y="4952555"/>
            <a:ext cx="898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+)</a:t>
            </a:r>
          </a:p>
          <a:p>
            <a:r>
              <a:rPr lang="en-US" sz="1200" dirty="0"/>
              <a:t>s32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006838ED-0EEB-4BEB-97C4-778661F5ECC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4707" y="4141063"/>
            <a:ext cx="4011386" cy="2613297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D08CB506-B9F7-4B68-A59A-036ECEE10850}"/>
              </a:ext>
            </a:extLst>
          </p:cNvPr>
          <p:cNvSpPr txBox="1"/>
          <p:nvPr/>
        </p:nvSpPr>
        <p:spPr>
          <a:xfrm>
            <a:off x="10341670" y="4517512"/>
            <a:ext cx="898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+)</a:t>
            </a:r>
          </a:p>
          <a:p>
            <a:r>
              <a:rPr lang="en-US" sz="1200" dirty="0"/>
              <a:t>s33</a:t>
            </a: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74BDB059-33C9-4086-89A9-AC39536CE6E3}"/>
              </a:ext>
            </a:extLst>
          </p:cNvPr>
          <p:cNvCxnSpPr>
            <a:cxnSpLocks/>
          </p:cNvCxnSpPr>
          <p:nvPr/>
        </p:nvCxnSpPr>
        <p:spPr>
          <a:xfrm>
            <a:off x="10860302" y="4673127"/>
            <a:ext cx="68736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C0F6D8BC-2C8C-4759-9E32-1931E8FA3ADB}"/>
              </a:ext>
            </a:extLst>
          </p:cNvPr>
          <p:cNvCxnSpPr>
            <a:cxnSpLocks/>
          </p:cNvCxnSpPr>
          <p:nvPr/>
        </p:nvCxnSpPr>
        <p:spPr>
          <a:xfrm>
            <a:off x="10860301" y="4854111"/>
            <a:ext cx="50774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E857937D-A17A-47FC-BC9A-F0E1474FFB9A}"/>
              </a:ext>
            </a:extLst>
          </p:cNvPr>
          <p:cNvCxnSpPr>
            <a:cxnSpLocks/>
          </p:cNvCxnSpPr>
          <p:nvPr/>
        </p:nvCxnSpPr>
        <p:spPr>
          <a:xfrm>
            <a:off x="6301647" y="5104482"/>
            <a:ext cx="41443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E5E5935B-B082-431D-9079-2C11D1B9FDEA}"/>
              </a:ext>
            </a:extLst>
          </p:cNvPr>
          <p:cNvCxnSpPr>
            <a:cxnSpLocks/>
          </p:cNvCxnSpPr>
          <p:nvPr/>
        </p:nvCxnSpPr>
        <p:spPr>
          <a:xfrm>
            <a:off x="6245770" y="5288224"/>
            <a:ext cx="117828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C7D8CA67-B275-471B-9D36-94D713D46C7B}"/>
              </a:ext>
            </a:extLst>
          </p:cNvPr>
          <p:cNvSpPr txBox="1"/>
          <p:nvPr/>
        </p:nvSpPr>
        <p:spPr>
          <a:xfrm>
            <a:off x="504218" y="6280665"/>
            <a:ext cx="3488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human; s20; s21; s22; s23; s25; s27; s28; s29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0857033-7BD1-4861-9139-7194E3CD5F9C}"/>
              </a:ext>
            </a:extLst>
          </p:cNvPr>
          <p:cNvSpPr txBox="1"/>
          <p:nvPr/>
        </p:nvSpPr>
        <p:spPr>
          <a:xfrm>
            <a:off x="5161131" y="6296886"/>
            <a:ext cx="1892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human; s30; s3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E251609-7BE1-401B-9A84-006B6897C142}"/>
              </a:ext>
            </a:extLst>
          </p:cNvPr>
          <p:cNvSpPr txBox="1"/>
          <p:nvPr/>
        </p:nvSpPr>
        <p:spPr>
          <a:xfrm>
            <a:off x="9747751" y="6218156"/>
            <a:ext cx="1100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rl</a:t>
            </a:r>
            <a:r>
              <a:rPr lang="en-US" sz="1200" dirty="0"/>
              <a:t>(-); human</a:t>
            </a:r>
          </a:p>
        </p:txBody>
      </p:sp>
    </p:spTree>
    <p:extLst>
      <p:ext uri="{BB962C8B-B14F-4D97-AF65-F5344CB8AC3E}">
        <p14:creationId xmlns:p14="http://schemas.microsoft.com/office/powerpoint/2010/main" val="988237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14</TotalTime>
  <Words>465</Words>
  <Application>Microsoft Office PowerPoint</Application>
  <PresentationFormat>Widescreen</PresentationFormat>
  <Paragraphs>5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ng Ngo</dc:creator>
  <cp:lastModifiedBy>Trung Ngo</cp:lastModifiedBy>
  <cp:revision>43</cp:revision>
  <dcterms:created xsi:type="dcterms:W3CDTF">2020-06-18T02:50:23Z</dcterms:created>
  <dcterms:modified xsi:type="dcterms:W3CDTF">2022-04-14T01:30:15Z</dcterms:modified>
</cp:coreProperties>
</file>